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3: </a:t>
            </a:r>
            <a:r>
              <a:rPr lang="en-GB" sz="1600" dirty="0" smtClean="0"/>
              <a:t>3D model structure and validation of</a:t>
            </a:r>
            <a:r>
              <a:rPr lang="en-US" sz="1600" dirty="0" smtClean="0"/>
              <a:t> KRAS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4dsu_A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4dsu_A 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57158" y="97515"/>
            <a:ext cx="2714644" cy="294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572132" y="71438"/>
            <a:ext cx="2643206" cy="304707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57157" y="3214686"/>
            <a:ext cx="2706221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572132" y="3214687"/>
            <a:ext cx="2643206" cy="279108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7</cp:revision>
  <dcterms:created xsi:type="dcterms:W3CDTF">2018-05-10T07:33:24Z</dcterms:created>
  <dcterms:modified xsi:type="dcterms:W3CDTF">2018-05-29T07:27:01Z</dcterms:modified>
</cp:coreProperties>
</file>